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7" r:id="rId1"/>
  </p:sldMasterIdLst>
  <p:notesMasterIdLst>
    <p:notesMasterId r:id="rId3"/>
  </p:notesMasterIdLst>
  <p:handoutMasterIdLst>
    <p:handoutMasterId r:id="rId4"/>
  </p:handoutMasterIdLst>
  <p:sldIdLst>
    <p:sldId id="397" r:id="rId2"/>
  </p:sldIdLst>
  <p:sldSz cx="6858000" cy="7772400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8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A121"/>
    <a:srgbClr val="FFFF00"/>
    <a:srgbClr val="00FA00"/>
    <a:srgbClr val="060606"/>
    <a:srgbClr val="00FEFF"/>
    <a:srgbClr val="942092"/>
    <a:srgbClr val="0333FF"/>
    <a:srgbClr val="EFEFEF"/>
    <a:srgbClr val="929292"/>
    <a:srgbClr val="FF2F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8182" autoAdjust="0"/>
    <p:restoredTop sz="93317" autoAdjust="0"/>
  </p:normalViewPr>
  <p:slideViewPr>
    <p:cSldViewPr snapToGrid="0">
      <p:cViewPr varScale="1">
        <p:scale>
          <a:sx n="70" d="100"/>
          <a:sy n="70" d="100"/>
        </p:scale>
        <p:origin x="2602" y="48"/>
      </p:cViewPr>
      <p:guideLst>
        <p:guide orient="horz" pos="244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266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40A61B-CF5D-774F-948C-68B65EAC25D5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FD6DF2-CEEB-3940-ACF5-6C6F136D1C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092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7FE934-E91C-8E47-9497-4DDBF27E2ED8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551238" y="857250"/>
            <a:ext cx="20415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8A7E76-F8F4-7040-96D9-FB2069C67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745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551238" y="857250"/>
            <a:ext cx="204152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8A7E76-F8F4-7040-96D9-FB2069C67A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73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272011"/>
            <a:ext cx="5829300" cy="270594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082310"/>
            <a:ext cx="5143500" cy="187653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13808"/>
            <a:ext cx="1478756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13808"/>
            <a:ext cx="4350544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37705"/>
            <a:ext cx="5915025" cy="323310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201393"/>
            <a:ext cx="5915025" cy="17002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069042"/>
            <a:ext cx="291465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069042"/>
            <a:ext cx="291465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13810"/>
            <a:ext cx="5915025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05318"/>
            <a:ext cx="2901255" cy="9337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839085"/>
            <a:ext cx="2901255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05318"/>
            <a:ext cx="2915543" cy="9337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839085"/>
            <a:ext cx="2915543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8160"/>
            <a:ext cx="2211884" cy="18135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19083"/>
            <a:ext cx="3471863" cy="55234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31720"/>
            <a:ext cx="2211884" cy="431980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8160"/>
            <a:ext cx="2211884" cy="18135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19083"/>
            <a:ext cx="3471863" cy="55234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31720"/>
            <a:ext cx="2211884" cy="431980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13810"/>
            <a:ext cx="5915025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069042"/>
            <a:ext cx="5915025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203865"/>
            <a:ext cx="154305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203865"/>
            <a:ext cx="2314575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203865"/>
            <a:ext cx="154305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592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emf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98865F3-6A72-BE44-8BA2-BA7B1CF8A9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5976" y="1003213"/>
            <a:ext cx="1803338" cy="2146833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 rot="16200000">
            <a:off x="-78108" y="1916317"/>
            <a:ext cx="16451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verage intensity (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.u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945205" y="2940915"/>
            <a:ext cx="151745" cy="214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16746" y="1052751"/>
            <a:ext cx="327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16746" y="1430384"/>
            <a:ext cx="327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16746" y="1808017"/>
            <a:ext cx="327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16746" y="2185650"/>
            <a:ext cx="327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16746" y="2563283"/>
            <a:ext cx="327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002659" y="3052483"/>
            <a:ext cx="63350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rpn-6.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88496" y="3052483"/>
            <a:ext cx="6399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1569267" y="1375546"/>
            <a:ext cx="7486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714508" y="1135950"/>
            <a:ext cx="45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8" name="TextBox 17"/>
          <p:cNvSpPr txBox="1">
            <a:spLocks noChangeAspect="1"/>
          </p:cNvSpPr>
          <p:nvPr/>
        </p:nvSpPr>
        <p:spPr>
          <a:xfrm>
            <a:off x="709156" y="827242"/>
            <a:ext cx="23089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drxIR1;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bG76V::Dendra2;Q40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AC60153-2459-754E-841B-3E09075290A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 flipH="1">
            <a:off x="945832" y="3753140"/>
            <a:ext cx="3434135" cy="77573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3C5145F-6491-A24B-BED7-ACDE7754E19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 flipH="1">
            <a:off x="945832" y="4566022"/>
            <a:ext cx="3434137" cy="77641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C936472-F038-914D-B063-CDDF280438C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V="1">
            <a:off x="945832" y="5465115"/>
            <a:ext cx="3437874" cy="77793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EE9D77C-A5A1-464B-AAE6-5564B161A55E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5828" y="6274917"/>
            <a:ext cx="3437875" cy="777259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F6A817A3-3E6A-B141-94C1-02B9095D6A14}"/>
              </a:ext>
            </a:extLst>
          </p:cNvPr>
          <p:cNvSpPr txBox="1"/>
          <p:nvPr/>
        </p:nvSpPr>
        <p:spPr>
          <a:xfrm>
            <a:off x="4393921" y="4017898"/>
            <a:ext cx="882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3E0B727-BCD1-7A48-AAA3-0367DFDA770A}"/>
              </a:ext>
            </a:extLst>
          </p:cNvPr>
          <p:cNvSpPr txBox="1"/>
          <p:nvPr/>
        </p:nvSpPr>
        <p:spPr>
          <a:xfrm>
            <a:off x="4393921" y="4831118"/>
            <a:ext cx="886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oag-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6A817A3-3E6A-B141-94C1-02B9095D6A14}"/>
              </a:ext>
            </a:extLst>
          </p:cNvPr>
          <p:cNvSpPr txBox="1"/>
          <p:nvPr/>
        </p:nvSpPr>
        <p:spPr>
          <a:xfrm>
            <a:off x="4393921" y="5694941"/>
            <a:ext cx="882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3E0B727-BCD1-7A48-AAA3-0367DFDA770A}"/>
              </a:ext>
            </a:extLst>
          </p:cNvPr>
          <p:cNvSpPr txBox="1"/>
          <p:nvPr/>
        </p:nvSpPr>
        <p:spPr>
          <a:xfrm>
            <a:off x="4393921" y="6497403"/>
            <a:ext cx="886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oag-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5141E13-5885-C642-8D1F-3B2033069B1C}"/>
              </a:ext>
            </a:extLst>
          </p:cNvPr>
          <p:cNvSpPr txBox="1"/>
          <p:nvPr/>
        </p:nvSpPr>
        <p:spPr>
          <a:xfrm rot="16200000">
            <a:off x="387059" y="4414334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Q40Bristo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45EBBE9-2601-C841-8B21-DF30DEB03A27}"/>
              </a:ext>
            </a:extLst>
          </p:cNvPr>
          <p:cNvSpPr txBox="1"/>
          <p:nvPr/>
        </p:nvSpPr>
        <p:spPr>
          <a:xfrm rot="16200000">
            <a:off x="369425" y="6135480"/>
            <a:ext cx="865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drxIR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;Q4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74696" y="60571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76484" y="366788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9079" y="7065181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oung adult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6A817A3-3E6A-B141-94C1-02B9095D6A14}"/>
              </a:ext>
            </a:extLst>
          </p:cNvPr>
          <p:cNvSpPr txBox="1"/>
          <p:nvPr/>
        </p:nvSpPr>
        <p:spPr>
          <a:xfrm>
            <a:off x="4393921" y="3479418"/>
            <a:ext cx="882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NAi:</a:t>
            </a:r>
          </a:p>
        </p:txBody>
      </p:sp>
    </p:spTree>
    <p:extLst>
      <p:ext uri="{BB962C8B-B14F-4D97-AF65-F5344CB8AC3E}">
        <p14:creationId xmlns:p14="http://schemas.microsoft.com/office/powerpoint/2010/main" val="313433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644</TotalTime>
  <Words>38</Words>
  <Application>Microsoft Office PowerPoint</Application>
  <PresentationFormat>Custom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Gidalevitz,Tali</cp:lastModifiedBy>
  <cp:revision>1075</cp:revision>
  <cp:lastPrinted>2017-09-26T17:26:17Z</cp:lastPrinted>
  <dcterms:created xsi:type="dcterms:W3CDTF">2016-05-03T15:43:04Z</dcterms:created>
  <dcterms:modified xsi:type="dcterms:W3CDTF">2020-02-11T22:43:06Z</dcterms:modified>
</cp:coreProperties>
</file>